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47" d="100"/>
          <a:sy n="47" d="100"/>
        </p:scale>
        <p:origin x="1348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A7CCA2-226D-D703-2256-C85EB75B3B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5E716CD-4954-E76B-7B80-FD1F291951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C64F8B-D6EA-2893-DBDC-074412DE6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92628F-E79E-2171-A186-F0C4CBC6C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F21236-07D2-4B8F-A958-F423C5E0D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021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D6152-5358-85DA-06A4-72E5B272F1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372C1A-506D-F2DF-36FF-273FD309F6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37CC65-422E-D05F-0EC5-724C2B2F4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82C57-C6BC-93F4-74F9-F2980A854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A09C9E-EDAF-1604-83B7-8E5649738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748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2E7F83-415F-4C40-EE45-AAE9138A8F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9EEBD5-405F-B1AC-0277-BA28F95BED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E60357-AAE9-DE24-02C3-219481993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C8986E-13F5-0F66-8992-9D73341F1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07696D-E661-9AB9-C6C2-B23B25607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5998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05401-19F5-0C72-FA7F-00EBDA1F75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789C89-BBE4-6202-BB5E-A0152A5938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1208E0-098C-1282-B553-6D02644C5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3DA79E-A724-E2E5-36DC-4326F2D20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0DCE7D-A19C-F327-A601-B2F1A20DB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3468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4567CD-E0B8-A4A0-9548-FD0427DCD6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92852A-6F5C-05AB-01E4-45A59EAD7D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3E33D4-FFFB-409E-9D77-F854CA5DD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7AEDDC-8923-47E3-A6EE-40B605D7A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AEEA93-65BE-C099-AFBE-9A87FF46C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6950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41DA98-6589-0035-D550-B1594BC6B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7804F4-F34F-E2DF-ECA8-F773A57E72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9EC9FD-7381-796F-C5B1-2CC3FDD5FB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14EF99-0063-6DD9-5308-B5799869D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DD09F5-9A8C-3E27-92E8-05981F927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E35EDE-C84A-AF56-A8BD-14FC92C8C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3893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17419-5E37-FCAE-B57A-03EBA9DC2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3E020C-9DD4-56F5-4CEE-546EAB63CB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85E61F-F032-72F9-C05D-6EBFAA7628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8DC980-4A65-F673-EB17-7199C48E06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A89CE4-8568-F8A8-CA8D-938606838D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295B77-0289-83B9-942A-4D9340320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F036B1C-62EB-7691-E9AD-7983B3B08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B56507-6BB2-7B14-125A-E5A687E87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4007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9F07C2-C0FC-2C8A-8CB5-65C99DCE25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7F9B16-AD8E-97D4-D718-D7AE62E0E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21694BC-D647-0C37-7D60-672D8F04B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E7814C-D24B-CB43-D548-A122BDE52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312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7DBF1C-AFE4-4B59-CF2B-A726BD1FA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6F7FC2-DD3D-848A-8347-322B21786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783CA1-AAC4-D371-A8C1-3F4A5C962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4101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8845EB-75EC-2FCA-9CCB-CC7A5A9D1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E32D46-671A-5475-31BA-FC97DD2790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3ECC4B-5F03-40BE-D78F-BC2905A5DA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8B284A-1C24-3066-2B16-EE5A30205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0FF004-0964-FBE9-7D90-E03F12060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849680-BB0D-B465-5F7C-05682B07A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4186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C781C-D86D-3801-8482-5D764299D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AC4795-16D3-9B72-5CC9-10123AFA5D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895E89-8E43-466C-15D4-54389586BF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3E378B-37E9-234B-3B7D-2FBEB55344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3FD2F6-D6E0-AC01-8B19-61CF25599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0D7769-FA63-C330-F949-94A6908A7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8075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F538D4-9AEE-6CBC-8FB3-73B015F7C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CC2662-C188-FC01-49D6-4FE4487457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E2AF53-B65D-AB4F-D54D-A84B8D7284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3363E4-3F51-4CE6-917A-132F463B9017}" type="datetimeFigureOut">
              <a:rPr lang="en-GB" smtClean="0"/>
              <a:t>13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7EF18D-5D0C-9438-3A3D-C15D100BD6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CD12D9-F7F5-F6C2-6A1B-D71D91D228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10015-B08F-4896-8708-CBF16B5857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9823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>
            <a:extLst>
              <a:ext uri="{FF2B5EF4-FFF2-40B4-BE49-F238E27FC236}">
                <a16:creationId xmlns:a16="http://schemas.microsoft.com/office/drawing/2014/main" id="{F71E4623-61AA-9E31-B7B5-B759E07E7C2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7317"/>
          <a:stretch/>
        </p:blipFill>
        <p:spPr>
          <a:xfrm>
            <a:off x="1571945" y="184070"/>
            <a:ext cx="6813761" cy="4120802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20BA8895-83FB-A5DF-656F-A745251DB3BA}"/>
              </a:ext>
            </a:extLst>
          </p:cNvPr>
          <p:cNvSpPr txBox="1"/>
          <p:nvPr/>
        </p:nvSpPr>
        <p:spPr>
          <a:xfrm>
            <a:off x="1684962" y="4654194"/>
            <a:ext cx="7017249" cy="15890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5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otnotes : </a:t>
            </a:r>
            <a:endParaRPr lang="en-GB" sz="105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50" baseline="3000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105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erived from average of 4 mammographic views Left breast CC, Right breast CC, Left breast MLO, Right breast MLO</a:t>
            </a:r>
            <a:endParaRPr lang="en-GB" sz="105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50" baseline="3000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GB" sz="105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he mean glandular dose estimation in mGy as provided by the manufacturer of the mammography equipment. Derived from average of 4 mammographic views Left breast CC, Right breast CC, Left breast MLO, Right breast MLO. Represents the estimated average absorbed radiation dose per unit of glandular tissue. </a:t>
            </a:r>
            <a:endParaRPr lang="en-GB" sz="18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GB" sz="18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273EA1C-DB51-3396-592C-FE8B795AD05E}"/>
              </a:ext>
            </a:extLst>
          </p:cNvPr>
          <p:cNvSpPr txBox="1"/>
          <p:nvPr/>
        </p:nvSpPr>
        <p:spPr>
          <a:xfrm>
            <a:off x="1665409" y="4304872"/>
            <a:ext cx="662683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2 Distribution of mammogram acquisition and outcome measurements</a:t>
            </a:r>
            <a:endParaRPr lang="en-GB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12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9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e</dc:creator>
  <cp:lastModifiedBy>Sue</cp:lastModifiedBy>
  <cp:revision>1</cp:revision>
  <dcterms:created xsi:type="dcterms:W3CDTF">2023-03-13T23:36:54Z</dcterms:created>
  <dcterms:modified xsi:type="dcterms:W3CDTF">2023-03-13T23:45:44Z</dcterms:modified>
</cp:coreProperties>
</file>